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031" y="9035901"/>
            <a:ext cx="67717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SNP-index plots for 20 pseudomolecules of LLS resistant bulk with the resistant paren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lines indicate the sliding window average of 2 Mb interval with 50 kb increment for SNP-index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7031" y="25533"/>
            <a:ext cx="6830575" cy="8740529"/>
            <a:chOff x="7031" y="25533"/>
            <a:chExt cx="6830575" cy="8740529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185"/>
            <a:stretch/>
          </p:blipFill>
          <p:spPr>
            <a:xfrm>
              <a:off x="7031" y="34290"/>
              <a:ext cx="2267481" cy="745542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111" r="2371" b="64716"/>
            <a:stretch/>
          </p:blipFill>
          <p:spPr>
            <a:xfrm>
              <a:off x="4599643" y="5009511"/>
              <a:ext cx="2237963" cy="2630571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37" r="52444" b="83042"/>
            <a:stretch/>
          </p:blipFill>
          <p:spPr>
            <a:xfrm>
              <a:off x="9548" y="7501741"/>
              <a:ext cx="2238062" cy="1264321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74" t="33201" r="27425"/>
            <a:stretch/>
          </p:blipFill>
          <p:spPr>
            <a:xfrm>
              <a:off x="4601332" y="25533"/>
              <a:ext cx="2236274" cy="498019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37" t="16822" r="52444"/>
            <a:stretch/>
          </p:blipFill>
          <p:spPr>
            <a:xfrm>
              <a:off x="2304098" y="46482"/>
              <a:ext cx="2238062" cy="6201261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74" r="27425" b="66416"/>
            <a:stretch/>
          </p:blipFill>
          <p:spPr>
            <a:xfrm>
              <a:off x="2310194" y="6253676"/>
              <a:ext cx="2236274" cy="25038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21517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0</TotalTime>
  <Words>34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89</cp:revision>
  <dcterms:created xsi:type="dcterms:W3CDTF">2015-04-20T11:32:42Z</dcterms:created>
  <dcterms:modified xsi:type="dcterms:W3CDTF">2016-09-26T10:48:08Z</dcterms:modified>
</cp:coreProperties>
</file>